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media/image8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244C77-9E35-47EA-BF1E-3FC425A0A3F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DADD47-910E-48DC-AC74-2E193261C8F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7DE132-35EF-4257-AD92-21B8899D7C0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BB4131-0ECA-491B-B89D-C0B67BFEF4B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2039D5-2EFD-47D4-959E-07C3856455F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AAD558-9A15-4FAD-A259-B4FF5A42708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CADE4A-330C-482D-92EA-D39247410A9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0AD6C5-7022-48F7-B03E-14FA0B4C51B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38783B-B8E0-4F3A-BD3A-E8DA95D48BC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DDF72E-E833-4630-9BA8-0D19ED2DE51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563B4E-D1E2-42E8-97CD-301700C6EF7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0A26E7-F68E-4723-81CD-8C0F224F528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2B564E5-99C5-4EC9-828E-61580AE2013C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252000" y="-360"/>
            <a:ext cx="889164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Calibri"/>
              </a:rPr>
              <a:t>A.HRs plot with the 95% CIs- Whole dataset</a:t>
            </a: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" name="Picture 4" descr=""/>
          <p:cNvPicPr/>
          <p:nvPr/>
        </p:nvPicPr>
        <p:blipFill>
          <a:blip r:embed="rId1"/>
          <a:stretch/>
        </p:blipFill>
        <p:spPr>
          <a:xfrm>
            <a:off x="368280" y="917640"/>
            <a:ext cx="8407440" cy="5607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3 - Τίτλος"/>
          <p:cNvSpPr/>
          <p:nvPr/>
        </p:nvSpPr>
        <p:spPr>
          <a:xfrm>
            <a:off x="108000" y="44280"/>
            <a:ext cx="8891640" cy="1143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500" spc="-1" strike="noStrike">
                <a:solidFill>
                  <a:srgbClr val="000000"/>
                </a:solidFill>
                <a:latin typeface="Calibri"/>
              </a:rPr>
              <a:t>B.HRs plot with the 95% CIs- Whole dataset</a:t>
            </a: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4" name="Picture 2" descr=""/>
          <p:cNvPicPr/>
          <p:nvPr/>
        </p:nvPicPr>
        <p:blipFill>
          <a:blip r:embed="rId1"/>
          <a:stretch/>
        </p:blipFill>
        <p:spPr>
          <a:xfrm>
            <a:off x="333360" y="915840"/>
            <a:ext cx="8477280" cy="55375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3 - Τίτλος"/>
          <p:cNvSpPr/>
          <p:nvPr/>
        </p:nvSpPr>
        <p:spPr>
          <a:xfrm>
            <a:off x="108000" y="44280"/>
            <a:ext cx="8891640" cy="1143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500" spc="-1" strike="noStrike">
                <a:solidFill>
                  <a:srgbClr val="000000"/>
                </a:solidFill>
                <a:latin typeface="Calibri"/>
              </a:rPr>
              <a:t>C.HRs plot with the 95% CIs- Whole dataset</a:t>
            </a: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6" name="Picture 7" descr=""/>
          <p:cNvPicPr/>
          <p:nvPr/>
        </p:nvPicPr>
        <p:blipFill>
          <a:blip r:embed="rId1"/>
          <a:srcRect l="0" t="1549" r="0" b="0"/>
          <a:stretch/>
        </p:blipFill>
        <p:spPr>
          <a:xfrm>
            <a:off x="590400" y="1008000"/>
            <a:ext cx="7963200" cy="54453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3 - Τίτλος"/>
          <p:cNvSpPr/>
          <p:nvPr/>
        </p:nvSpPr>
        <p:spPr>
          <a:xfrm>
            <a:off x="108000" y="44280"/>
            <a:ext cx="8891640" cy="1143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500" spc="-1" strike="noStrike">
                <a:solidFill>
                  <a:srgbClr val="000000"/>
                </a:solidFill>
                <a:latin typeface="Calibri"/>
              </a:rPr>
              <a:t>D.HRs plot with the 95% CIs- Whole dataset</a:t>
            </a: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8" name="Picture 4" descr=""/>
          <p:cNvPicPr/>
          <p:nvPr/>
        </p:nvPicPr>
        <p:blipFill>
          <a:blip r:embed="rId1"/>
          <a:stretch/>
        </p:blipFill>
        <p:spPr>
          <a:xfrm>
            <a:off x="577800" y="979560"/>
            <a:ext cx="7988400" cy="54738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3 - Τίτλος"/>
          <p:cNvSpPr/>
          <p:nvPr/>
        </p:nvSpPr>
        <p:spPr>
          <a:xfrm>
            <a:off x="108000" y="44280"/>
            <a:ext cx="8891640" cy="1143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500" spc="-1" strike="noStrike">
                <a:solidFill>
                  <a:srgbClr val="000000"/>
                </a:solidFill>
                <a:latin typeface="Calibri"/>
              </a:rPr>
              <a:t>E.HRs plot with the 95% CIs- Luminal A and B</a:t>
            </a: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0" name="Picture 2" descr=""/>
          <p:cNvPicPr/>
          <p:nvPr/>
        </p:nvPicPr>
        <p:blipFill>
          <a:blip r:embed="rId1"/>
          <a:stretch/>
        </p:blipFill>
        <p:spPr>
          <a:xfrm>
            <a:off x="415800" y="884160"/>
            <a:ext cx="8312400" cy="55692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3 - Τίτλος"/>
          <p:cNvSpPr/>
          <p:nvPr/>
        </p:nvSpPr>
        <p:spPr>
          <a:xfrm>
            <a:off x="108000" y="44280"/>
            <a:ext cx="8891640" cy="1143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500" spc="-1" strike="noStrike">
                <a:solidFill>
                  <a:srgbClr val="000000"/>
                </a:solidFill>
                <a:latin typeface="Calibri"/>
              </a:rPr>
              <a:t>F.HRs plot with the 95% CIs- Luminal A and B</a:t>
            </a: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2" name="Picture 2" descr=""/>
          <p:cNvPicPr/>
          <p:nvPr/>
        </p:nvPicPr>
        <p:blipFill>
          <a:blip r:embed="rId1"/>
          <a:stretch/>
        </p:blipFill>
        <p:spPr>
          <a:xfrm>
            <a:off x="514440" y="895320"/>
            <a:ext cx="8115120" cy="54864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3 - Τίτλος"/>
          <p:cNvSpPr/>
          <p:nvPr/>
        </p:nvSpPr>
        <p:spPr>
          <a:xfrm>
            <a:off x="108000" y="44280"/>
            <a:ext cx="8891640" cy="1143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500" spc="-1" strike="noStrike">
                <a:solidFill>
                  <a:srgbClr val="000000"/>
                </a:solidFill>
                <a:latin typeface="Calibri"/>
              </a:rPr>
              <a:t>G.HRs plot with the 95% CIs- Luminal A and B</a:t>
            </a: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4" name="Picture 4" descr=""/>
          <p:cNvPicPr/>
          <p:nvPr/>
        </p:nvPicPr>
        <p:blipFill>
          <a:blip r:embed="rId1"/>
          <a:stretch/>
        </p:blipFill>
        <p:spPr>
          <a:xfrm>
            <a:off x="552600" y="901800"/>
            <a:ext cx="8038800" cy="54799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3 - Τίτλος"/>
          <p:cNvSpPr/>
          <p:nvPr/>
        </p:nvSpPr>
        <p:spPr>
          <a:xfrm>
            <a:off x="108000" y="44280"/>
            <a:ext cx="8891640" cy="1143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500" spc="-1" strike="noStrike">
                <a:solidFill>
                  <a:srgbClr val="000000"/>
                </a:solidFill>
                <a:latin typeface="Calibri"/>
              </a:rPr>
              <a:t>H.HRs plot with the 95% CIs- Luminal A and B</a:t>
            </a: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6" name="Picture 4" descr=""/>
          <p:cNvPicPr/>
          <p:nvPr/>
        </p:nvPicPr>
        <p:blipFill>
          <a:blip r:embed="rId1"/>
          <a:stretch/>
        </p:blipFill>
        <p:spPr>
          <a:xfrm>
            <a:off x="514440" y="907920"/>
            <a:ext cx="8115120" cy="54864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1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11-28T15:31:11Z</dcterms:created>
  <dc:creator>George Kouvatseas</dc:creator>
  <dc:description/>
  <dc:language>en-US</dc:language>
  <cp:lastModifiedBy>GIANNIS MOUNTZIOS</cp:lastModifiedBy>
  <dcterms:modified xsi:type="dcterms:W3CDTF">2014-01-15T21:37:26Z</dcterms:modified>
  <cp:revision>51</cp:revision>
  <dc:subject/>
  <dc:title>Supplementary figure 2</dc:title>
</cp:coreProperties>
</file>